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pct" ContentType="image/x-pict"/>
  <Override PartName="/ppt/media/image2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F9E140-1A06-4809-9B6B-BE97D4757B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A684D-FAFD-47A9-A023-C55E94FF82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C1D823-DB4B-4A9E-AEEB-62E35A03E6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1EEE0-D249-4890-BE6A-A5E25928EA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8C6C2-E527-42EB-BCD1-410C70E734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55EB5C-2780-41C7-BAF1-A2F8A73CDD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37AF24-89C2-49BE-9AE7-F3FBBC411E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67393-8552-4350-AF88-F4BE22CAFB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A0F521-C775-4E5E-A3E0-2B5759E12B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70C2F3-4015-4DF9-B8C5-31F374FB14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8ABD8-C5E8-4ADD-B12B-23CA164E68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1B1BE-4E0B-4233-A925-BCF6437D1C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E47618-5109-43A1-B05D-D74F717C9E5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ct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80880" y="609480"/>
          <a:ext cx="8506080" cy="24386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80880" y="609480"/>
                    <a:ext cx="8506080" cy="2438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304920" y="3124080"/>
          <a:ext cx="8610480" cy="35053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04920" y="3124080"/>
                    <a:ext cx="8610480" cy="3505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1676520" y="6583320"/>
            <a:ext cx="495288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404040"/>
                </a:solidFill>
                <a:latin typeface="Arial"/>
              </a:rPr>
              <a:t>Spearman Rank Order Correlation, r</a:t>
            </a:r>
            <a:r>
              <a:rPr b="1" lang="en-US" sz="1200" spc="-1" strike="noStrike" baseline="-25000">
                <a:solidFill>
                  <a:srgbClr val="404040"/>
                </a:solidFill>
                <a:latin typeface="Arial"/>
              </a:rPr>
              <a:t>s</a:t>
            </a:r>
            <a:r>
              <a:rPr b="1" lang="en-US" sz="1200" spc="-1" strike="noStrike">
                <a:solidFill>
                  <a:srgbClr val="404040"/>
                </a:solidFill>
                <a:latin typeface="Arial"/>
              </a:rPr>
              <a:t> = +0.43  (n = 67, p &lt; 0.00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48600">
            <a:off x="-166680" y="144792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KBr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48600">
            <a:off x="-1089000" y="4443120"/>
            <a:ext cx="2568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rbB2+ tumors (n=10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06000" y="0"/>
            <a:ext cx="8472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333399"/>
                </a:solidFill>
                <a:latin typeface="Arial"/>
              </a:rPr>
              <a:t>Similar miRNAs Expressed in ErbB2+ Cell Line &amp; Tumor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3-15T13:58:29Z</dcterms:created>
  <dc:creator>Chris Benz User</dc:creator>
  <dc:description/>
  <dc:language>en-US</dc:language>
  <cp:lastModifiedBy>Chris Benz User</cp:lastModifiedBy>
  <dcterms:modified xsi:type="dcterms:W3CDTF">2006-03-29T16:48:10Z</dcterms:modified>
  <cp:revision>38</cp:revision>
  <dc:subject/>
  <dc:title>PowerPoint Presentation</dc:title>
</cp:coreProperties>
</file>